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E0593D-26AD-4B83-AFF6-9694F906328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4EF1D0-11AA-47FE-B63E-646C6033D6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F76E45-74F2-4E5F-A2A3-B151B9E0B8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593468-BC67-40F3-B3CF-A2724803690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46B955-4F17-4B4B-92CE-2EF8200256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4730A4-10ED-45D3-B37A-D5D8D37327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5267F4-63D8-423C-87E3-7310AC991F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E7318B-46E5-403B-B7A2-B79F7B0140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4184BA-A579-4AFA-AFE2-19ED3B3208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44C9FF-DF52-4F10-B38D-A1E4CFD272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939653-0FF2-4D85-8F4C-C9CA10B36C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2249F6-C4E1-4556-B366-0E5737C79E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CFCEA7D-59DC-4801-98F7-BB140D2C1373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494F3C7-5B85-431C-A301-B22CF9EC8AA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"/>
          <p:cNvSpPr/>
          <p:nvPr/>
        </p:nvSpPr>
        <p:spPr>
          <a:xfrm>
            <a:off x="182520" y="4724280"/>
            <a:ext cx="895500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gure S7. Comparison of Cdc20 profiles cycling over the course of a 101.2 minute cell cycle. Time-varying Cdc20 concentration (scaled from arbitrary units to mol/cell) from the original Chen model [45] is shown in green, while our modification of the Cdc20 profile is shown in blue. In the latter case, the formula specifying levels of the Cdc20 inhibitor, Mad2 replaces a step function with a smoothed function. This results in lower Cdc20 levels in mid and late G1 phase,  allowing Dbf4 to gradually accumulate eventually peaking by the end of S phase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12" descr="Cdc20 profiles overlayed.eps"/>
          <p:cNvPicPr/>
          <p:nvPr/>
        </p:nvPicPr>
        <p:blipFill>
          <a:blip r:embed="rId1"/>
          <a:stretch/>
        </p:blipFill>
        <p:spPr>
          <a:xfrm>
            <a:off x="1549440" y="380880"/>
            <a:ext cx="5689440" cy="4267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19T22:17:56Z</dcterms:created>
  <dc:creator>Rohan Gidvani</dc:creator>
  <dc:description/>
  <dc:language>en-US</dc:language>
  <cp:lastModifiedBy>Rohan Gidvani</cp:lastModifiedBy>
  <cp:lastPrinted>2012-04-19T22:24:33Z</cp:lastPrinted>
  <dcterms:modified xsi:type="dcterms:W3CDTF">2012-06-17T22:26:34Z</dcterms:modified>
  <cp:revision>7</cp:revision>
  <dc:subject/>
  <dc:title>Slide 1</dc:title>
</cp:coreProperties>
</file>